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1.xml" ContentType="application/vnd.openxmlformats-officedocument.theme+xml"/>
  <Override PartName="/ppt/charts/style6.xml" ContentType="application/vnd.ms-office.chartstyle+xml"/>
  <Override PartName="/ppt/charts/chart1.xml" ContentType="application/vnd.openxmlformats-officedocument.drawingml.chart+xml"/>
  <Override PartName="/ppt/charts/chart4.xml" ContentType="application/vnd.openxmlformats-officedocument.drawingml.chart+xml"/>
  <Override PartName="/ppt/charts/colors3.xml" ContentType="application/vnd.ms-office.chartcolorstyle+xml"/>
  <Override PartName="/ppt/charts/style3.xml" ContentType="application/vnd.ms-office.chartstyle+xml"/>
  <Override PartName="/ppt/charts/chart3.xml" ContentType="application/vnd.openxmlformats-officedocument.drawingml.chart+xml"/>
  <Override PartName="/ppt/charts/colors2.xml" ContentType="application/vnd.ms-office.chartcolorstyle+xml"/>
  <Override PartName="/ppt/charts/style2.xml" ContentType="application/vnd.ms-office.chartstyle+xml"/>
  <Override PartName="/ppt/charts/chart2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charts/colors7.xml" ContentType="application/vnd.ms-office.chartcolorstyle+xml"/>
  <Override PartName="/ppt/charts/style4.xml" ContentType="application/vnd.ms-office.chartstyle+xml"/>
  <Override PartName="/ppt/charts/chart5.xml" ContentType="application/vnd.openxmlformats-officedocument.drawingml.chart+xml"/>
  <Override PartName="/ppt/charts/colors4.xml" ContentType="application/vnd.ms-office.chartcolorstyle+xml"/>
  <Override PartName="/ppt/charts/chart7.xml" ContentType="application/vnd.openxmlformats-officedocument.drawingml.chart+xml"/>
  <Override PartName="/ppt/charts/colors6.xml" ContentType="application/vnd.ms-office.chartcolorstyle+xml"/>
  <Override PartName="/ppt/charts/style7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300" y="8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F%20by%20F%204%20A\Figure%207\7c-d\supplementary%20cell%20counts%20graphs%20with%20other%20T%20cell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PD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1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461C6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E05-4219-A476-0347C203687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E05-4219-A476-0347C203687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E05-4219-A476-0347C203687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E05-4219-A476-0347C203687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E05-4219-A476-0347C203687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E05-4219-A476-0347C203687C}"/>
              </c:ext>
            </c:extLst>
          </c:dPt>
          <c:dPt>
            <c:idx val="6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E05-4219-A476-0347C203687C}"/>
              </c:ext>
            </c:extLst>
          </c:dPt>
          <c:dPt>
            <c:idx val="7"/>
            <c:bubble3D val="0"/>
            <c:spPr>
              <a:solidFill>
                <a:schemeClr val="tx2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E05-4219-A476-0347C203687C}"/>
              </c:ext>
            </c:extLst>
          </c:dPt>
          <c:cat>
            <c:strRef>
              <c:f>'immune profiling T and B good'!$L$2:$L$9</c:f>
              <c:strCache>
                <c:ptCount val="8"/>
                <c:pt idx="0">
                  <c:v>Macrophages</c:v>
                </c:pt>
                <c:pt idx="1">
                  <c:v>NKs</c:v>
                </c:pt>
                <c:pt idx="2">
                  <c:v>Monocytes</c:v>
                </c:pt>
                <c:pt idx="3">
                  <c:v>DCs</c:v>
                </c:pt>
                <c:pt idx="4">
                  <c:v>mast cells</c:v>
                </c:pt>
                <c:pt idx="5">
                  <c:v>plasma cells</c:v>
                </c:pt>
                <c:pt idx="6">
                  <c:v>B cells</c:v>
                </c:pt>
                <c:pt idx="7">
                  <c:v>T cells</c:v>
                </c:pt>
              </c:strCache>
            </c:strRef>
          </c:cat>
          <c:val>
            <c:numRef>
              <c:f>'immune profiling T and B good'!$M$2:$M$9</c:f>
              <c:numCache>
                <c:formatCode>General</c:formatCode>
                <c:ptCount val="8"/>
                <c:pt idx="0">
                  <c:v>21.416735708367852</c:v>
                </c:pt>
                <c:pt idx="1">
                  <c:v>7.1043910521955258</c:v>
                </c:pt>
                <c:pt idx="2">
                  <c:v>5.4473902236951117</c:v>
                </c:pt>
                <c:pt idx="3">
                  <c:v>9.4759734879867441</c:v>
                </c:pt>
                <c:pt idx="4">
                  <c:v>1.356669428334714</c:v>
                </c:pt>
                <c:pt idx="5">
                  <c:v>0.12427506213753108</c:v>
                </c:pt>
                <c:pt idx="6">
                  <c:v>3.572908036454018</c:v>
                </c:pt>
                <c:pt idx="7">
                  <c:v>27.8583264291632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E05-4219-A476-0347C20368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98F-471E-BDDC-36FF80FB45E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98F-471E-BDDC-36FF80FB45E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98F-471E-BDDC-36FF80FB45E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98F-471E-BDDC-36FF80FB45E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98F-471E-BDDC-36FF80FB45E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98F-471E-BDDC-36FF80FB45E5}"/>
              </c:ext>
            </c:extLst>
          </c:dPt>
          <c:dPt>
            <c:idx val="6"/>
            <c:bubble3D val="0"/>
            <c:spPr>
              <a:solidFill>
                <a:srgbClr val="461C6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98F-471E-BDDC-36FF80FB45E5}"/>
              </c:ext>
            </c:extLst>
          </c:dPt>
          <c:dPt>
            <c:idx val="7"/>
            <c:bubble3D val="0"/>
            <c:spPr>
              <a:solidFill>
                <a:srgbClr val="2D384A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98F-471E-BDDC-36FF80FB45E5}"/>
              </c:ext>
            </c:extLst>
          </c:dPt>
          <c:cat>
            <c:strRef>
              <c:f>'immune profiling T and B good'!$L$2:$L$9</c:f>
              <c:strCache>
                <c:ptCount val="8"/>
                <c:pt idx="0">
                  <c:v>Macrophages</c:v>
                </c:pt>
                <c:pt idx="1">
                  <c:v>NKs</c:v>
                </c:pt>
                <c:pt idx="2">
                  <c:v>Monocytes</c:v>
                </c:pt>
                <c:pt idx="3">
                  <c:v>DCs</c:v>
                </c:pt>
                <c:pt idx="4">
                  <c:v>mast cells</c:v>
                </c:pt>
                <c:pt idx="5">
                  <c:v>plasma cells</c:v>
                </c:pt>
                <c:pt idx="6">
                  <c:v>B cells</c:v>
                </c:pt>
                <c:pt idx="7">
                  <c:v>T cells</c:v>
                </c:pt>
              </c:strCache>
            </c:strRef>
          </c:cat>
          <c:val>
            <c:numRef>
              <c:f>'immune profiling T and B good'!$Q$2:$Q$9</c:f>
              <c:numCache>
                <c:formatCode>General</c:formatCode>
                <c:ptCount val="8"/>
                <c:pt idx="0">
                  <c:v>7.8981723237597921</c:v>
                </c:pt>
                <c:pt idx="1">
                  <c:v>7.8981723237597921</c:v>
                </c:pt>
                <c:pt idx="2">
                  <c:v>20.642950391644909</c:v>
                </c:pt>
                <c:pt idx="3">
                  <c:v>11.814621409921671</c:v>
                </c:pt>
                <c:pt idx="4">
                  <c:v>2.9862924281984333</c:v>
                </c:pt>
                <c:pt idx="5">
                  <c:v>0.60378590078328997</c:v>
                </c:pt>
                <c:pt idx="6">
                  <c:v>4.0633159268929502</c:v>
                </c:pt>
                <c:pt idx="7">
                  <c:v>24.39621409921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98F-471E-BDDC-36FF80FB45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0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991-437D-89E9-71C855F0B321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991-437D-89E9-71C855F0B321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991-437D-89E9-71C855F0B321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991-437D-89E9-71C855F0B321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991-437D-89E9-71C855F0B321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991-437D-89E9-71C855F0B321}"/>
              </c:ext>
            </c:extLst>
          </c:dPt>
          <c:dPt>
            <c:idx val="6"/>
            <c:bubble3D val="0"/>
            <c:spPr>
              <a:solidFill>
                <a:srgbClr val="461C6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991-437D-89E9-71C855F0B321}"/>
              </c:ext>
            </c:extLst>
          </c:dPt>
          <c:dPt>
            <c:idx val="7"/>
            <c:bubble3D val="0"/>
            <c:spPr>
              <a:solidFill>
                <a:srgbClr val="2D384A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991-437D-89E9-71C855F0B321}"/>
              </c:ext>
            </c:extLst>
          </c:dPt>
          <c:cat>
            <c:strRef>
              <c:f>'immune profiling T and B good'!$L$2:$L$9</c:f>
              <c:strCache>
                <c:ptCount val="8"/>
                <c:pt idx="0">
                  <c:v>Macrophages</c:v>
                </c:pt>
                <c:pt idx="1">
                  <c:v>NKs</c:v>
                </c:pt>
                <c:pt idx="2">
                  <c:v>Monocytes</c:v>
                </c:pt>
                <c:pt idx="3">
                  <c:v>DCs</c:v>
                </c:pt>
                <c:pt idx="4">
                  <c:v>mast cells</c:v>
                </c:pt>
                <c:pt idx="5">
                  <c:v>plasma cells</c:v>
                </c:pt>
                <c:pt idx="6">
                  <c:v>B cells</c:v>
                </c:pt>
                <c:pt idx="7">
                  <c:v>T cells</c:v>
                </c:pt>
              </c:strCache>
            </c:strRef>
          </c:cat>
          <c:val>
            <c:numRef>
              <c:f>'immune profiling T and B good'!$S$2:$S$9</c:f>
              <c:numCache>
                <c:formatCode>General</c:formatCode>
                <c:ptCount val="8"/>
                <c:pt idx="0">
                  <c:v>6.4775160599571739</c:v>
                </c:pt>
                <c:pt idx="1">
                  <c:v>3.8410064239828694</c:v>
                </c:pt>
                <c:pt idx="2">
                  <c:v>9.3147751605995719</c:v>
                </c:pt>
                <c:pt idx="3">
                  <c:v>9.6895074946466799</c:v>
                </c:pt>
                <c:pt idx="4">
                  <c:v>1.2847965738758029</c:v>
                </c:pt>
                <c:pt idx="5">
                  <c:v>3.0246252676659529</c:v>
                </c:pt>
                <c:pt idx="6">
                  <c:v>3.3458244111349038</c:v>
                </c:pt>
                <c:pt idx="7">
                  <c:v>27.9041755888650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991-437D-89E9-71C855F0B3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0" i="0" u="none" strike="noStrike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11 + </a:t>
            </a:r>
            <a:r>
              <a:rPr lang="en-US" sz="1200" b="0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PD-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461C6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1E9-4B8C-994E-2B76938728F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1E9-4B8C-994E-2B76938728F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1E9-4B8C-994E-2B76938728F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1E9-4B8C-994E-2B76938728F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1E9-4B8C-994E-2B76938728F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1E9-4B8C-994E-2B76938728F9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1E9-4B8C-994E-2B76938728F9}"/>
              </c:ext>
            </c:extLst>
          </c:dPt>
          <c:dPt>
            <c:idx val="7"/>
            <c:bubble3D val="0"/>
            <c:spPr>
              <a:solidFill>
                <a:schemeClr val="tx2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1E9-4B8C-994E-2B76938728F9}"/>
              </c:ext>
            </c:extLst>
          </c:dPt>
          <c:cat>
            <c:strRef>
              <c:f>'immune profiling T and B good'!$L$2:$L$9</c:f>
              <c:strCache>
                <c:ptCount val="8"/>
                <c:pt idx="0">
                  <c:v>Macrophages</c:v>
                </c:pt>
                <c:pt idx="1">
                  <c:v>NKs</c:v>
                </c:pt>
                <c:pt idx="2">
                  <c:v>Monocytes</c:v>
                </c:pt>
                <c:pt idx="3">
                  <c:v>DCs</c:v>
                </c:pt>
                <c:pt idx="4">
                  <c:v>mast cells</c:v>
                </c:pt>
                <c:pt idx="5">
                  <c:v>plasma cells</c:v>
                </c:pt>
                <c:pt idx="6">
                  <c:v>B cells</c:v>
                </c:pt>
                <c:pt idx="7">
                  <c:v>T cells</c:v>
                </c:pt>
              </c:strCache>
            </c:strRef>
          </c:cat>
          <c:val>
            <c:numRef>
              <c:f>'immune profiling T and B good'!$O$2:$O$9</c:f>
              <c:numCache>
                <c:formatCode>General</c:formatCode>
                <c:ptCount val="8"/>
                <c:pt idx="0">
                  <c:v>20.65772290157901</c:v>
                </c:pt>
                <c:pt idx="1">
                  <c:v>12.786418140804939</c:v>
                </c:pt>
                <c:pt idx="2">
                  <c:v>10.506945268906566</c:v>
                </c:pt>
                <c:pt idx="3">
                  <c:v>5.0457081799833787</c:v>
                </c:pt>
                <c:pt idx="4">
                  <c:v>1.4721595631010329</c:v>
                </c:pt>
                <c:pt idx="5">
                  <c:v>0.43927341802208242</c:v>
                </c:pt>
                <c:pt idx="6">
                  <c:v>3.5498041078000711</c:v>
                </c:pt>
                <c:pt idx="7">
                  <c:v>25.4659859907396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1E9-4B8C-994E-2B76938728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PD-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164-47C0-AA56-9679B1B26BB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164-47C0-AA56-9679B1B26BB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164-47C0-AA56-9679B1B26BB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164-47C0-AA56-9679B1B26BB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164-47C0-AA56-9679B1B26BB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164-47C0-AA56-9679B1B26BBE}"/>
              </c:ext>
            </c:extLst>
          </c:dPt>
          <c:dPt>
            <c:idx val="6"/>
            <c:bubble3D val="0"/>
            <c:spPr>
              <a:solidFill>
                <a:srgbClr val="461C6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164-47C0-AA56-9679B1B26BBE}"/>
              </c:ext>
            </c:extLst>
          </c:dPt>
          <c:dPt>
            <c:idx val="7"/>
            <c:bubble3D val="0"/>
            <c:spPr>
              <a:solidFill>
                <a:srgbClr val="2D384A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164-47C0-AA56-9679B1B26BBE}"/>
              </c:ext>
            </c:extLst>
          </c:dPt>
          <c:cat>
            <c:strRef>
              <c:f>'immune profiling T and B good'!$L$2:$L$9</c:f>
              <c:strCache>
                <c:ptCount val="8"/>
                <c:pt idx="0">
                  <c:v>Macrophages</c:v>
                </c:pt>
                <c:pt idx="1">
                  <c:v>NKs</c:v>
                </c:pt>
                <c:pt idx="2">
                  <c:v>Monocytes</c:v>
                </c:pt>
                <c:pt idx="3">
                  <c:v>DCs</c:v>
                </c:pt>
                <c:pt idx="4">
                  <c:v>mast cells</c:v>
                </c:pt>
                <c:pt idx="5">
                  <c:v>plasma cells</c:v>
                </c:pt>
                <c:pt idx="6">
                  <c:v>B cells</c:v>
                </c:pt>
                <c:pt idx="7">
                  <c:v>T cells</c:v>
                </c:pt>
              </c:strCache>
            </c:strRef>
          </c:cat>
          <c:val>
            <c:numRef>
              <c:f>'immune profiling T and B good'!$U$2:$U$9</c:f>
              <c:numCache>
                <c:formatCode>General</c:formatCode>
                <c:ptCount val="8"/>
                <c:pt idx="0">
                  <c:v>10.849862078024431</c:v>
                </c:pt>
                <c:pt idx="1">
                  <c:v>6.5677131222908178</c:v>
                </c:pt>
                <c:pt idx="2">
                  <c:v>7.3032969919873905</c:v>
                </c:pt>
                <c:pt idx="3">
                  <c:v>8.4986207802443197</c:v>
                </c:pt>
                <c:pt idx="4">
                  <c:v>1.9571785104426638</c:v>
                </c:pt>
                <c:pt idx="5">
                  <c:v>0.21016681991330616</c:v>
                </c:pt>
                <c:pt idx="6">
                  <c:v>4.5842637593589908</c:v>
                </c:pt>
                <c:pt idx="7">
                  <c:v>32.510179955339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9164-47C0-AA56-9679B1B26B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718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023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874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425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153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772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351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882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683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8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12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8FC90C-DCD3-4A2B-B14D-9967C59088C6}" type="datetimeFigureOut">
              <a:rPr lang="en-US" smtClean="0"/>
              <a:t>3/2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4C955-5EE2-4052-9DB9-372FBA75F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467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BEDAF6C-C7C8-8370-EB23-107B13C01BF0}"/>
              </a:ext>
            </a:extLst>
          </p:cNvPr>
          <p:cNvSpPr txBox="1"/>
          <p:nvPr/>
        </p:nvSpPr>
        <p:spPr>
          <a:xfrm>
            <a:off x="0" y="83127"/>
            <a:ext cx="2884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FBD05C60-D1A2-B64E-84DF-0C37CA0B87C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914541" y="3693683"/>
          <a:ext cx="6046318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323A5863-C1B4-0448-9CA5-1B6596C8A9E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920354" y="204785"/>
          <a:ext cx="4094583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E8A1AC00-5A3C-9146-B0EF-72593C2E208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-345108" y="188951"/>
          <a:ext cx="4026235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22FAFA4C-4C29-1840-9063-EB3C29D02F8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600893" y="232642"/>
          <a:ext cx="4069926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FFDB54A2-1ACA-E742-9132-8AE432E348D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57031" y="237578"/>
          <a:ext cx="4086109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61AE9F89-43E3-D14C-8BA4-AFA41544E11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929096" y="227706"/>
          <a:ext cx="4035778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9C3E9E85-A244-4C4A-B0C4-2019C7EE516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-379587" y="3646918"/>
          <a:ext cx="3991921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9" name="Rectangle 58"/>
          <p:cNvSpPr/>
          <p:nvPr/>
        </p:nvSpPr>
        <p:spPr>
          <a:xfrm rot="19945279">
            <a:off x="531806" y="1940243"/>
            <a:ext cx="103906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3985272" y="1299727"/>
            <a:ext cx="103906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6275328" y="1313149"/>
            <a:ext cx="103906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 rot="17196053">
            <a:off x="7915271" y="2291804"/>
            <a:ext cx="103906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3" name="Rectangle 62"/>
          <p:cNvSpPr/>
          <p:nvPr/>
        </p:nvSpPr>
        <p:spPr>
          <a:xfrm rot="16806440">
            <a:off x="10336364" y="2288215"/>
            <a:ext cx="103906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835026" y="1298810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3182348" y="1333433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5510551" y="1349476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7765774" y="1642327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10150794" y="1644665"/>
            <a:ext cx="5934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1729660" y="1833727"/>
            <a:ext cx="8659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 rot="2831940">
            <a:off x="3982412" y="2216307"/>
            <a:ext cx="8659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5986557" y="2530010"/>
            <a:ext cx="8659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/>
          <p:cNvSpPr/>
          <p:nvPr/>
        </p:nvSpPr>
        <p:spPr>
          <a:xfrm>
            <a:off x="11151302" y="1763249"/>
            <a:ext cx="8659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8782825" y="1597358"/>
            <a:ext cx="86594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1972695" y="1218671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Ks</a:t>
            </a:r>
          </a:p>
        </p:txBody>
      </p:sp>
      <p:sp>
        <p:nvSpPr>
          <p:cNvPr id="75" name="Rectangle 74"/>
          <p:cNvSpPr/>
          <p:nvPr/>
        </p:nvSpPr>
        <p:spPr>
          <a:xfrm>
            <a:off x="4567236" y="1967277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K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6691954" y="1981015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K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9012933" y="1103398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K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11406527" y="1426363"/>
            <a:ext cx="45236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K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/>
          <p:cNvSpPr/>
          <p:nvPr/>
        </p:nvSpPr>
        <p:spPr>
          <a:xfrm rot="18438545">
            <a:off x="795867" y="2243250"/>
            <a:ext cx="6014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80" name="Rectangle 79"/>
          <p:cNvSpPr/>
          <p:nvPr/>
        </p:nvSpPr>
        <p:spPr>
          <a:xfrm rot="18365644">
            <a:off x="3142116" y="2253973"/>
            <a:ext cx="6014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81" name="Rectangle 80"/>
          <p:cNvSpPr/>
          <p:nvPr/>
        </p:nvSpPr>
        <p:spPr>
          <a:xfrm rot="19414899">
            <a:off x="5243132" y="2134677"/>
            <a:ext cx="6014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82" name="Rectangle 81"/>
          <p:cNvSpPr/>
          <p:nvPr/>
        </p:nvSpPr>
        <p:spPr>
          <a:xfrm rot="4344628">
            <a:off x="8548742" y="2462583"/>
            <a:ext cx="6014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83" name="Rectangle 82"/>
          <p:cNvSpPr/>
          <p:nvPr/>
        </p:nvSpPr>
        <p:spPr>
          <a:xfrm rot="15291136">
            <a:off x="10799881" y="2535228"/>
            <a:ext cx="6014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84" name="Rectangle 83"/>
          <p:cNvSpPr/>
          <p:nvPr/>
        </p:nvSpPr>
        <p:spPr>
          <a:xfrm rot="17290409">
            <a:off x="1442582" y="1040274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st cells</a:t>
            </a:r>
          </a:p>
        </p:txBody>
      </p:sp>
      <p:sp>
        <p:nvSpPr>
          <p:cNvPr id="85" name="Rectangle 84"/>
          <p:cNvSpPr/>
          <p:nvPr/>
        </p:nvSpPr>
        <p:spPr>
          <a:xfrm rot="17560321">
            <a:off x="8427395" y="1086733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st cells</a:t>
            </a:r>
          </a:p>
        </p:txBody>
      </p:sp>
      <p:sp>
        <p:nvSpPr>
          <p:cNvPr id="86" name="Rectangle 85"/>
          <p:cNvSpPr/>
          <p:nvPr/>
        </p:nvSpPr>
        <p:spPr>
          <a:xfrm rot="18202769">
            <a:off x="10833455" y="1103398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st cells</a:t>
            </a:r>
          </a:p>
        </p:txBody>
      </p:sp>
      <p:sp>
        <p:nvSpPr>
          <p:cNvPr id="87" name="Rectangle 86"/>
          <p:cNvSpPr/>
          <p:nvPr/>
        </p:nvSpPr>
        <p:spPr>
          <a:xfrm>
            <a:off x="1291118" y="2408575"/>
            <a:ext cx="4603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Cs</a:t>
            </a:r>
          </a:p>
        </p:txBody>
      </p:sp>
      <p:sp>
        <p:nvSpPr>
          <p:cNvPr id="88" name="Rectangle 87"/>
          <p:cNvSpPr/>
          <p:nvPr/>
        </p:nvSpPr>
        <p:spPr>
          <a:xfrm>
            <a:off x="3708282" y="2428584"/>
            <a:ext cx="4603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Cs</a:t>
            </a:r>
          </a:p>
        </p:txBody>
      </p:sp>
      <p:sp>
        <p:nvSpPr>
          <p:cNvPr id="89" name="Rectangle 88"/>
          <p:cNvSpPr/>
          <p:nvPr/>
        </p:nvSpPr>
        <p:spPr>
          <a:xfrm>
            <a:off x="5707276" y="2351225"/>
            <a:ext cx="4603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Cs</a:t>
            </a:r>
          </a:p>
        </p:txBody>
      </p:sp>
      <p:sp>
        <p:nvSpPr>
          <p:cNvPr id="90" name="Rectangle 89"/>
          <p:cNvSpPr/>
          <p:nvPr/>
        </p:nvSpPr>
        <p:spPr>
          <a:xfrm>
            <a:off x="8932843" y="2195769"/>
            <a:ext cx="4603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Cs</a:t>
            </a:r>
          </a:p>
        </p:txBody>
      </p:sp>
      <p:sp>
        <p:nvSpPr>
          <p:cNvPr id="91" name="Rectangle 90"/>
          <p:cNvSpPr/>
          <p:nvPr/>
        </p:nvSpPr>
        <p:spPr>
          <a:xfrm>
            <a:off x="11211457" y="2269340"/>
            <a:ext cx="46038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Cs</a:t>
            </a:r>
          </a:p>
        </p:txBody>
      </p:sp>
      <p:sp>
        <p:nvSpPr>
          <p:cNvPr id="92" name="Rectangle 91"/>
          <p:cNvSpPr/>
          <p:nvPr/>
        </p:nvSpPr>
        <p:spPr>
          <a:xfrm rot="19590230">
            <a:off x="597214" y="2111747"/>
            <a:ext cx="9028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cells</a:t>
            </a:r>
          </a:p>
        </p:txBody>
      </p:sp>
      <p:sp>
        <p:nvSpPr>
          <p:cNvPr id="94" name="Rectangle 93"/>
          <p:cNvSpPr/>
          <p:nvPr/>
        </p:nvSpPr>
        <p:spPr>
          <a:xfrm rot="18969253">
            <a:off x="2955103" y="2118785"/>
            <a:ext cx="9028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cells</a:t>
            </a:r>
          </a:p>
        </p:txBody>
      </p:sp>
      <p:sp>
        <p:nvSpPr>
          <p:cNvPr id="95" name="Rectangle 94"/>
          <p:cNvSpPr/>
          <p:nvPr/>
        </p:nvSpPr>
        <p:spPr>
          <a:xfrm rot="19096856">
            <a:off x="5245563" y="2150919"/>
            <a:ext cx="9028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cells</a:t>
            </a:r>
          </a:p>
        </p:txBody>
      </p:sp>
      <p:sp>
        <p:nvSpPr>
          <p:cNvPr id="96" name="Rectangle 95"/>
          <p:cNvSpPr/>
          <p:nvPr/>
        </p:nvSpPr>
        <p:spPr>
          <a:xfrm rot="16200000">
            <a:off x="8183164" y="2347164"/>
            <a:ext cx="9028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cells</a:t>
            </a:r>
          </a:p>
        </p:txBody>
      </p:sp>
      <p:sp>
        <p:nvSpPr>
          <p:cNvPr id="97" name="Rectangle 96"/>
          <p:cNvSpPr/>
          <p:nvPr/>
        </p:nvSpPr>
        <p:spPr>
          <a:xfrm rot="17287549">
            <a:off x="10229203" y="2334269"/>
            <a:ext cx="9028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cells</a:t>
            </a:r>
          </a:p>
        </p:txBody>
      </p:sp>
      <p:sp>
        <p:nvSpPr>
          <p:cNvPr id="98" name="Rectangle 97"/>
          <p:cNvSpPr/>
          <p:nvPr/>
        </p:nvSpPr>
        <p:spPr>
          <a:xfrm rot="17821766">
            <a:off x="3223830" y="2246805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st cells</a:t>
            </a:r>
          </a:p>
        </p:txBody>
      </p:sp>
      <p:sp>
        <p:nvSpPr>
          <p:cNvPr id="99" name="Rectangle 98"/>
          <p:cNvSpPr/>
          <p:nvPr/>
        </p:nvSpPr>
        <p:spPr>
          <a:xfrm rot="18801071">
            <a:off x="5335581" y="2250280"/>
            <a:ext cx="8114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st cells</a:t>
            </a:r>
          </a:p>
        </p:txBody>
      </p:sp>
    </p:spTree>
    <p:extLst>
      <p:ext uri="{BB962C8B-B14F-4D97-AF65-F5344CB8AC3E}">
        <p14:creationId xmlns:p14="http://schemas.microsoft.com/office/powerpoint/2010/main" val="227921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7B9B2C6527ED4B872425A61FB2348D" ma:contentTypeVersion="13" ma:contentTypeDescription="Create a new document." ma:contentTypeScope="" ma:versionID="eab3e5c1ba249a1d86109643abc49beb">
  <xsd:schema xmlns:xsd="http://www.w3.org/2001/XMLSchema" xmlns:xs="http://www.w3.org/2001/XMLSchema" xmlns:p="http://schemas.microsoft.com/office/2006/metadata/properties" xmlns:ns2="a1c1925a-ca81-4b92-a099-ee59e54d030a" xmlns:ns3="86f5bbeb-a984-4fb2-bd57-831a897c44b1" targetNamespace="http://schemas.microsoft.com/office/2006/metadata/properties" ma:root="true" ma:fieldsID="4bd9371b356dbe3cb9af3a490a76fa85" ns2:_="" ns3:_="">
    <xsd:import namespace="a1c1925a-ca81-4b92-a099-ee59e54d030a"/>
    <xsd:import namespace="86f5bbeb-a984-4fb2-bd57-831a897c44b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OCR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1c1925a-ca81-4b92-a099-ee59e54d030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4b2c965b-d860-41d6-b67e-2baa6ffbc59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6f5bbeb-a984-4fb2-bd57-831a897c44b1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012befff-b5e3-44f3-a870-0e1b3c30fa1a}" ma:internalName="TaxCatchAll" ma:showField="CatchAllData" ma:web="86f5bbeb-a984-4fb2-bd57-831a897c44b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86f5bbeb-a984-4fb2-bd57-831a897c44b1" xsi:nil="true"/>
    <lcf76f155ced4ddcb4097134ff3c332f xmlns="a1c1925a-ca81-4b92-a099-ee59e54d030a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8C2DB26E-066F-4592-949D-71AE916CA3B7}"/>
</file>

<file path=customXml/itemProps2.xml><?xml version="1.0" encoding="utf-8"?>
<ds:datastoreItem xmlns:ds="http://schemas.openxmlformats.org/officeDocument/2006/customXml" ds:itemID="{7DEF539A-99C9-4179-B897-7FDABD39D138}"/>
</file>

<file path=customXml/itemProps3.xml><?xml version="1.0" encoding="utf-8"?>
<ds:datastoreItem xmlns:ds="http://schemas.openxmlformats.org/officeDocument/2006/customXml" ds:itemID="{D048BC42-1741-4A9E-9191-08F131CE32FE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Widescreen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bhani, Navid</dc:creator>
  <cp:lastModifiedBy>Sobhani, Navid</cp:lastModifiedBy>
  <cp:revision>2</cp:revision>
  <dcterms:created xsi:type="dcterms:W3CDTF">2023-03-21T16:13:57Z</dcterms:created>
  <dcterms:modified xsi:type="dcterms:W3CDTF">2023-03-21T16:33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F7B9B2C6527ED4B872425A61FB2348D</vt:lpwstr>
  </property>
</Properties>
</file>